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1" r:id="rId3"/>
    <p:sldId id="262" r:id="rId4"/>
    <p:sldId id="264" r:id="rId5"/>
    <p:sldId id="265" r:id="rId6"/>
  </p:sldIdLst>
  <p:sldSz cx="9906000" cy="6858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124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9990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7607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5126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3363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9478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8702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4039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7710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6804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1728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40490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29F3F9-3386-4B5C-98CE-4961BCC8EFC3}" type="datetimeFigureOut">
              <a:rPr lang="zh-CN" altLang="en-US" smtClean="0"/>
              <a:t>2024/6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F218EF-3C24-47B0-B6FF-9C53F15B0D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9715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矩形 21"/>
          <p:cNvSpPr/>
          <p:nvPr/>
        </p:nvSpPr>
        <p:spPr>
          <a:xfrm>
            <a:off x="142644" y="162812"/>
            <a:ext cx="268368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T for Fig.3C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图片 2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59" t="5737" r="4921" b="2257"/>
          <a:stretch/>
        </p:blipFill>
        <p:spPr>
          <a:xfrm>
            <a:off x="3740727" y="3920841"/>
            <a:ext cx="3574473" cy="2854037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5344029" y="686032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pG2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965703" y="686032"/>
            <a:ext cx="10919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pG2.2.1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7784221" y="5230187"/>
            <a:ext cx="1755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 (37k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左箭头 28"/>
          <p:cNvSpPr/>
          <p:nvPr/>
        </p:nvSpPr>
        <p:spPr>
          <a:xfrm>
            <a:off x="7436485" y="5347859"/>
            <a:ext cx="286620" cy="1339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/>
          <a:srcRect l="34321" t="22274" b="19116"/>
          <a:stretch/>
        </p:blipFill>
        <p:spPr>
          <a:xfrm>
            <a:off x="3740727" y="1108104"/>
            <a:ext cx="3574473" cy="2688037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7784218" y="1415026"/>
            <a:ext cx="17556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T(55k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左箭头 11"/>
          <p:cNvSpPr/>
          <p:nvPr/>
        </p:nvSpPr>
        <p:spPr>
          <a:xfrm>
            <a:off x="7436485" y="1532698"/>
            <a:ext cx="286620" cy="1339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037378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矩形 21"/>
          <p:cNvSpPr/>
          <p:nvPr/>
        </p:nvSpPr>
        <p:spPr>
          <a:xfrm>
            <a:off x="0" y="233200"/>
            <a:ext cx="264521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T for Fig.3F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7562550" y="1847908"/>
            <a:ext cx="17556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T(55k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左箭头 28"/>
          <p:cNvSpPr/>
          <p:nvPr/>
        </p:nvSpPr>
        <p:spPr>
          <a:xfrm>
            <a:off x="7214817" y="5181599"/>
            <a:ext cx="286620" cy="1339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0767" y="3986660"/>
            <a:ext cx="5224999" cy="270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5021" y="1194992"/>
            <a:ext cx="4878674" cy="2700000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7562553" y="5063927"/>
            <a:ext cx="1755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 (37k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左箭头 13"/>
          <p:cNvSpPr/>
          <p:nvPr/>
        </p:nvSpPr>
        <p:spPr>
          <a:xfrm>
            <a:off x="7214817" y="1965580"/>
            <a:ext cx="286620" cy="1339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968275" y="841068"/>
            <a:ext cx="3840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lu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HBV    0     0.25    0.5      (</a:t>
            </a:r>
            <a:r>
              <a:rPr lang="en-US" altLang="zh-CN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5070764" y="1194992"/>
            <a:ext cx="2002931" cy="5663008"/>
          </a:xfrm>
          <a:prstGeom prst="rect">
            <a:avLst/>
          </a:prstGeom>
          <a:noFill/>
          <a:ln w="38100">
            <a:solidFill>
              <a:srgbClr val="0070C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39374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矩形 21"/>
          <p:cNvSpPr/>
          <p:nvPr/>
        </p:nvSpPr>
        <p:spPr>
          <a:xfrm>
            <a:off x="180109" y="579458"/>
            <a:ext cx="256506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T for Fig.3I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7562550" y="1944893"/>
            <a:ext cx="17556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T(55k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左箭头 28"/>
          <p:cNvSpPr/>
          <p:nvPr/>
        </p:nvSpPr>
        <p:spPr>
          <a:xfrm>
            <a:off x="7214817" y="5181599"/>
            <a:ext cx="286620" cy="1339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7562553" y="5063927"/>
            <a:ext cx="1755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 (37k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左箭头 13"/>
          <p:cNvSpPr/>
          <p:nvPr/>
        </p:nvSpPr>
        <p:spPr>
          <a:xfrm>
            <a:off x="7214817" y="2062565"/>
            <a:ext cx="286620" cy="1339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940565" y="841068"/>
            <a:ext cx="3840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Blu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HBV    0      0.25     0.5      (</a:t>
            </a:r>
            <a:r>
              <a:rPr lang="en-US" altLang="zh-CN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1328" y="3965587"/>
            <a:ext cx="5036228" cy="270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0003" y="1237993"/>
            <a:ext cx="4850299" cy="2700000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5070765" y="1194992"/>
            <a:ext cx="1903758" cy="5663008"/>
          </a:xfrm>
          <a:prstGeom prst="rect">
            <a:avLst/>
          </a:prstGeom>
          <a:noFill/>
          <a:ln w="38100">
            <a:solidFill>
              <a:srgbClr val="0070C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73350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矩形 21"/>
          <p:cNvSpPr/>
          <p:nvPr/>
        </p:nvSpPr>
        <p:spPr>
          <a:xfrm>
            <a:off x="55924" y="395048"/>
            <a:ext cx="270452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T for Fig.4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左箭头 28"/>
          <p:cNvSpPr/>
          <p:nvPr/>
        </p:nvSpPr>
        <p:spPr>
          <a:xfrm>
            <a:off x="7214817" y="5181599"/>
            <a:ext cx="286620" cy="1339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7562553" y="5063927"/>
            <a:ext cx="1755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 (37k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35"/>
          <a:stretch/>
        </p:blipFill>
        <p:spPr>
          <a:xfrm>
            <a:off x="2633099" y="2589916"/>
            <a:ext cx="5148185" cy="1980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16"/>
          <a:stretch/>
        </p:blipFill>
        <p:spPr>
          <a:xfrm>
            <a:off x="2760447" y="4691262"/>
            <a:ext cx="4393254" cy="980674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3764246" y="2131580"/>
            <a:ext cx="40170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ag-QPCT    0           1                (</a:t>
            </a:r>
            <a:r>
              <a:rPr lang="en-US" altLang="zh-CN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7562553" y="3524311"/>
            <a:ext cx="17556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T(55k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左箭头 13"/>
          <p:cNvSpPr/>
          <p:nvPr/>
        </p:nvSpPr>
        <p:spPr>
          <a:xfrm>
            <a:off x="7214820" y="3641983"/>
            <a:ext cx="286620" cy="1339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75722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矩形 21"/>
          <p:cNvSpPr/>
          <p:nvPr/>
        </p:nvSpPr>
        <p:spPr>
          <a:xfrm>
            <a:off x="0" y="175003"/>
            <a:ext cx="270452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T for Fig.4D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806939" y="2639826"/>
            <a:ext cx="17556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PCT(55k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左箭头 28"/>
          <p:cNvSpPr/>
          <p:nvPr/>
        </p:nvSpPr>
        <p:spPr>
          <a:xfrm>
            <a:off x="5459205" y="5763490"/>
            <a:ext cx="286620" cy="1339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806941" y="5645818"/>
            <a:ext cx="1755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PDH (37kD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左箭头 13"/>
          <p:cNvSpPr/>
          <p:nvPr/>
        </p:nvSpPr>
        <p:spPr>
          <a:xfrm>
            <a:off x="5459206" y="2757498"/>
            <a:ext cx="286620" cy="1339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  <a:solidFill>
                <a:srgbClr val="FF00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629664" y="1928517"/>
            <a:ext cx="35771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ag-QPCT    0            1       (</a:t>
            </a:r>
            <a:r>
              <a:rPr lang="en-US" altLang="zh-CN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0758"/>
          <a:stretch/>
        </p:blipFill>
        <p:spPr>
          <a:xfrm>
            <a:off x="2810004" y="2297849"/>
            <a:ext cx="2510141" cy="2160000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62192"/>
          <a:stretch/>
        </p:blipFill>
        <p:spPr>
          <a:xfrm>
            <a:off x="3406951" y="4494004"/>
            <a:ext cx="1982467" cy="1800000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417673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</TotalTime>
  <Words>73</Words>
  <Application>Microsoft Office PowerPoint</Application>
  <PresentationFormat>A4 纸张(210x297 毫米)</PresentationFormat>
  <Paragraphs>21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2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chi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20</cp:revision>
  <dcterms:created xsi:type="dcterms:W3CDTF">2024-05-28T15:22:59Z</dcterms:created>
  <dcterms:modified xsi:type="dcterms:W3CDTF">2024-06-10T16:00:23Z</dcterms:modified>
</cp:coreProperties>
</file>